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814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434" y="11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Google Shape;84;p13">
            <a:extLst>
              <a:ext uri="{FF2B5EF4-FFF2-40B4-BE49-F238E27FC236}">
                <a16:creationId xmlns:a16="http://schemas.microsoft.com/office/drawing/2014/main" id="{5DE40F32-C15D-40EF-BE20-3D9A7C79DD59}"/>
              </a:ext>
            </a:extLst>
          </p:cNvPr>
          <p:cNvSpPr/>
          <p:nvPr/>
        </p:nvSpPr>
        <p:spPr>
          <a:xfrm>
            <a:off x="337553" y="5181246"/>
            <a:ext cx="10698747" cy="14926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algn="just">
              <a:lnSpc>
                <a:spcPct val="107000"/>
              </a:lnSpc>
            </a:pPr>
            <a:r>
              <a:rPr lang="en-US" altLang="ko-KR" sz="1000" b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(A-C). 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CR amplification of 16S primer (</a:t>
            </a:r>
            <a:r>
              <a:rPr lang="en-US" altLang="ko-KR" sz="1000" dirty="0">
                <a:solidFill>
                  <a:srgbClr val="212121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6S rRNA, </a:t>
            </a:r>
            <a:r>
              <a:rPr lang="en-US" altLang="ko-KR" sz="10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_F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Ba_R1) was used for amplification of 19 </a:t>
            </a:r>
            <a:r>
              <a:rPr lang="en-US" altLang="ko-KR" sz="10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cillus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pecies from wild animal fecal [upon using the first (</a:t>
            </a:r>
            <a:r>
              <a:rPr lang="en-US" altLang="ko-KR" sz="10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_F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R) sequencing primer of forward primer, </a:t>
            </a:r>
            <a:r>
              <a:rPr lang="en-US" altLang="ko-KR" sz="10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_F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second (Ba_F1/R1) sequencing primer of reverse primer, Ba_R1), see in the Table 1]. </a:t>
            </a:r>
            <a:r>
              <a:rPr lang="en-US" altLang="ko-KR" sz="1000" b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NP-based </a:t>
            </a:r>
            <a:r>
              <a:rPr lang="en-US" altLang="ko-KR" sz="1000" dirty="0">
                <a:solidFill>
                  <a:srgbClr val="212121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er (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cF1m/R1m) was developed by natural and artificial mutated bases at the 3` end of triplet bases of each primer </a:t>
            </a:r>
            <a:r>
              <a:rPr lang="en-US" altLang="ko-KR" sz="1000" b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ilarly, SNP-based (BcF2m/BCR2m) </a:t>
            </a:r>
            <a:r>
              <a:rPr lang="en-US" altLang="ko-KR" sz="1000" dirty="0">
                <a:solidFill>
                  <a:srgbClr val="212121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er 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s developed for </a:t>
            </a:r>
            <a:r>
              <a:rPr lang="en-US" altLang="ko-KR" sz="10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cillus cereus 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up specific identification. ‘M’ indicate DNA 100bp marker, The gel lane numbers are  as follows: (accession no. of isolated </a:t>
            </a:r>
            <a:r>
              <a:rPr lang="en-US" altLang="ko-KR" sz="10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cillus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s, 1-19) No.1 = MF139612; No.2 = MF139613 ; No.3 = MF139615 ; No.4 = MF139625 ; No.5 = MF139627 ; No.6 = MF139629; No.7 = MF139628 ; No.8 =chimeric sequence (No Accession No) ; No.9 = MF139626 ; No.10 = MF139620 ; No.11 = MF139619 ; No.12 = MF139621; No.13 = MF139622 ; No.14 = MF139616; No.15 = MF139617; No.16= MF139623; No.17 = MF139624; No.18 = MF139614; No.19 = MF139618;. and non-</a:t>
            </a:r>
            <a:r>
              <a:rPr lang="en-US" altLang="ko-KR" sz="10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cillus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p. lane no I-V) </a:t>
            </a:r>
            <a:r>
              <a:rPr lang="en-US" altLang="ko-KR" sz="10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.I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</a:t>
            </a:r>
            <a:r>
              <a:rPr lang="en-US" altLang="ko-KR" sz="10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lmonella enterica 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CCP-15756); </a:t>
            </a:r>
            <a:r>
              <a:rPr lang="en-US" altLang="ko-KR" sz="10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.II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ko-KR" sz="10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. coli  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CCP-14034); </a:t>
            </a:r>
            <a:r>
              <a:rPr lang="en-US" altLang="ko-KR" sz="10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.III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</a:t>
            </a:r>
            <a:r>
              <a:rPr lang="en-US" altLang="ko-KR" sz="10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igella </a:t>
            </a:r>
            <a:r>
              <a:rPr lang="en-US" altLang="ko-KR" sz="10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ysenteriae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NCCP-14746), </a:t>
            </a:r>
            <a:r>
              <a:rPr lang="en-US" altLang="ko-KR" sz="10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.IV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ko-KR" sz="10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terobacter cloacae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10173), </a:t>
            </a:r>
            <a:r>
              <a:rPr lang="en-US" altLang="ko-KR" sz="10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.V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</a:t>
            </a:r>
            <a:r>
              <a:rPr lang="en-US" altLang="ko-KR" sz="10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seudomonas aeruginosa </a:t>
            </a:r>
            <a:r>
              <a:rPr lang="en-US" altLang="ko-KR" sz="1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CCP-16099) and No.VI = only PCR mixture without sample DNA as negative control. </a:t>
            </a:r>
            <a:endParaRPr lang="ko-KR" altLang="ko-KR" sz="1000" kern="100" dirty="0"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1DF0DD33-C049-4E81-8A56-C12106C631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7641" y="88900"/>
            <a:ext cx="7099437" cy="51050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09416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3</TotalTime>
  <Words>345</Words>
  <Application>Microsoft Office PowerPoint</Application>
  <PresentationFormat>와이드스크린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Palatino Linotype</vt:lpstr>
      <vt:lpstr>Times New Roman</vt:lpstr>
      <vt:lpstr>Office Them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ldlife10</dc:creator>
  <cp:lastModifiedBy>Md Mafizur Rahman</cp:lastModifiedBy>
  <cp:revision>78</cp:revision>
  <dcterms:modified xsi:type="dcterms:W3CDTF">2022-03-25T17:55:24Z</dcterms:modified>
</cp:coreProperties>
</file>